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0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A7D3AE-FD6A-4789-9B00-C3B52BB406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9D8193-48C6-4EE4-98BC-DAB25B2162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97F7CF-689D-4296-BEF2-B002C838C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4421FA-2CEA-4A73-AEFA-3A267B98D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8A4E49-C068-418B-9900-198B9ED1A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769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09297A-0959-44F8-AE53-E17474162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F386C67-2716-4B1E-83A7-AD80E534B5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326D29-F0A6-4402-9A11-42E9FABFA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BC6F67-D654-4312-9586-14372A41B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B0BA22-2BBA-42E9-A483-807B71D2D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211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0747380-2C5F-4274-B8EF-F7A9B6622C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AB2CF4D-DD9E-48DD-8F13-C12D8DA600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B0CC29-7344-473F-8A25-65C9E1E63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41C83B-95AD-41DC-A8D8-E4EE79269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7F63B-433F-4113-A816-8D90A67F7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86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8FE2A9-222F-4335-8AA3-23C2535234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0015C8-612A-4C04-92F0-F62205E63E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523B75-C0A0-439E-B8E0-78BA78713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64C7E3-8F1D-482E-80B5-FFCB830A8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513D93-0B4F-4906-85C6-D75F24A11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693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0E46A8-C12A-4C42-A09C-77D0807DB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BC6810B-30DA-47BB-BB5E-185D8EB6A6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5096C4-8AF4-42A3-9A09-0D4BC8400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03D041-D3FE-468A-BBD1-F039DE18E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C1E2B1-4870-4C69-9E1B-5F9834BD5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72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9BB923-4AB1-47FE-85BD-28B030B3CA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159CB9-2CE4-4EDC-BB12-30E5149F8C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608FA5-0363-4492-BED6-F8DA012AAB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1AB7075-11F8-4676-8BD2-E834DBA02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C9D8E5-1ECB-4F9C-8C6A-DF653E8B7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924899-D372-4E1D-A376-0C0BD9020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04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9C6B51-1C9D-456F-B8B2-32FAEEF1E0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F345C7-5D26-4468-A473-FD81C5834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D272F5-8D0E-4616-9C37-9890B3C10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E7898EE-0F94-4989-A645-FF839F9259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73DC4F6-F25E-4142-83B1-595A85A083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E88ADFF-76AB-4D51-BE40-ACF54ADFC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E8F8829-82BD-453C-94E5-90C0A3EFC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085CC5A-E17A-431D-B000-E71996264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485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6A3FA2-10C1-46ED-899B-3BACDFF8CA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05F8648-7F0E-459D-88B2-EF5A1AC7C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16C0A6E-BC15-4725-82EE-DE94EA0E0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10F3C3D-FB6F-4918-9B7B-3B0FAFFAC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571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579A9F-19F7-4E81-9808-606FF4CEE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B2C5ED1-46D2-4F44-8F92-D92649E61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036E51D-D556-406E-9E73-DA0B4D40B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551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AAEA77-BFD6-4AEE-B27B-1D56D3A12A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3CC88A4-DD3A-4164-A3C2-8284D55882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E3D90CC-2856-417F-BA86-9E68A159F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EFBBEE6-42B0-4AF0-94BA-E8AAD7A52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A0A171D-A084-4497-A10E-B7BFFBEBA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6BA20D-1219-410B-902C-555D86F62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545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95CEF1-63EC-4DE1-B25F-7BA7C9F11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D94D870-BF78-4A73-8FAE-D56578C934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5D21A87-1290-4C4B-896D-FA9EB79499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DAD79D7-A0D0-4A10-9FA7-A51D94231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46EC205-AE0F-4F51-B294-D732E9F81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AC3D729-9189-4D42-933F-39D5BD8C3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635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B29BFA6-57B4-4A99-BF69-F4C35121F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DFB5DC-410A-4412-B235-53C4952CCE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F5C177-BA61-49B6-9CC8-40AED76E1F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2E52D-F3EF-490F-8CF2-FE783D73228A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F6F444-2010-4008-ADF8-8F0236F29B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BFAD4C-7F67-48DF-8739-C5616C6790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80C56-0732-4F09-B493-2A67ED520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16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4D19044D-E378-42A7-B2D3-1C59127C46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6337" y="521199"/>
            <a:ext cx="3433894" cy="5815601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4813F65-C131-498C-A3CF-170282402658}"/>
              </a:ext>
            </a:extLst>
          </p:cNvPr>
          <p:cNvSpPr txBox="1"/>
          <p:nvPr/>
        </p:nvSpPr>
        <p:spPr>
          <a:xfrm>
            <a:off x="162046" y="151867"/>
            <a:ext cx="4472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1  Tissue malonyl-CoA content (Fig.2)</a:t>
            </a:r>
          </a:p>
        </p:txBody>
      </p:sp>
    </p:spTree>
    <p:extLst>
      <p:ext uri="{BB962C8B-B14F-4D97-AF65-F5344CB8AC3E}">
        <p14:creationId xmlns:p14="http://schemas.microsoft.com/office/powerpoint/2010/main" val="1588873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143B4C3-CE10-4A3D-A815-5BAEB6FBAB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056" y="1138493"/>
            <a:ext cx="10560061" cy="458101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2C9768E-6F75-427B-800F-C98134BA4F9A}"/>
              </a:ext>
            </a:extLst>
          </p:cNvPr>
          <p:cNvSpPr txBox="1"/>
          <p:nvPr/>
        </p:nvSpPr>
        <p:spPr>
          <a:xfrm>
            <a:off x="196770" y="151867"/>
            <a:ext cx="40253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2  Change of body weight (Fig.4)</a:t>
            </a:r>
          </a:p>
        </p:txBody>
      </p:sp>
    </p:spTree>
    <p:extLst>
      <p:ext uri="{BB962C8B-B14F-4D97-AF65-F5344CB8AC3E}">
        <p14:creationId xmlns:p14="http://schemas.microsoft.com/office/powerpoint/2010/main" val="22997933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EF8F5E3-C89B-4152-BBFC-C083C2FABA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3737" y="565866"/>
            <a:ext cx="3864525" cy="572626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77CC862-CAF3-425A-964C-28CD36706225}"/>
              </a:ext>
            </a:extLst>
          </p:cNvPr>
          <p:cNvSpPr txBox="1"/>
          <p:nvPr/>
        </p:nvSpPr>
        <p:spPr>
          <a:xfrm>
            <a:off x="254643" y="196534"/>
            <a:ext cx="4232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3  Cumulative calorie intake (Fig.4)</a:t>
            </a:r>
          </a:p>
        </p:txBody>
      </p:sp>
    </p:spTree>
    <p:extLst>
      <p:ext uri="{BB962C8B-B14F-4D97-AF65-F5344CB8AC3E}">
        <p14:creationId xmlns:p14="http://schemas.microsoft.com/office/powerpoint/2010/main" val="10787331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1AE1E80-44FA-4263-AD38-8288FDCFC0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0187" y="926542"/>
            <a:ext cx="11111626" cy="473020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996396D-A6BC-4AE6-B175-6E26842A4FDC}"/>
              </a:ext>
            </a:extLst>
          </p:cNvPr>
          <p:cNvSpPr txBox="1"/>
          <p:nvPr/>
        </p:nvSpPr>
        <p:spPr>
          <a:xfrm>
            <a:off x="254643" y="196534"/>
            <a:ext cx="4663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4  Plasma parameters (Fig.5, 9, Table 1)</a:t>
            </a:r>
          </a:p>
        </p:txBody>
      </p:sp>
    </p:spTree>
    <p:extLst>
      <p:ext uri="{BB962C8B-B14F-4D97-AF65-F5344CB8AC3E}">
        <p14:creationId xmlns:p14="http://schemas.microsoft.com/office/powerpoint/2010/main" val="33183242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3B94F51-CA21-492E-9BA9-0417024CF2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4447" y="737773"/>
            <a:ext cx="7154281" cy="5760214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5DB9D72-CC25-48AB-A5A1-7ACE79ECF0F6}"/>
              </a:ext>
            </a:extLst>
          </p:cNvPr>
          <p:cNvSpPr txBox="1"/>
          <p:nvPr/>
        </p:nvSpPr>
        <p:spPr>
          <a:xfrm>
            <a:off x="254643" y="196534"/>
            <a:ext cx="4013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5  Liver parameters (Fig.6, 9, 10)</a:t>
            </a:r>
          </a:p>
        </p:txBody>
      </p:sp>
    </p:spTree>
    <p:extLst>
      <p:ext uri="{BB962C8B-B14F-4D97-AF65-F5344CB8AC3E}">
        <p14:creationId xmlns:p14="http://schemas.microsoft.com/office/powerpoint/2010/main" val="10524225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460DA69-1CBB-48B6-B8D9-DA4D1FA851A9}"/>
              </a:ext>
            </a:extLst>
          </p:cNvPr>
          <p:cNvSpPr txBox="1"/>
          <p:nvPr/>
        </p:nvSpPr>
        <p:spPr>
          <a:xfrm>
            <a:off x="254643" y="196534"/>
            <a:ext cx="4915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6  Gene expression analysis (Fig.8, S1 Fig.)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BD9DF16-AEB0-4D28-B257-DEB57FEEA4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399" y="556933"/>
            <a:ext cx="11281201" cy="5744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60321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5477229-E5A1-427A-BED1-99B4EC828381}"/>
              </a:ext>
            </a:extLst>
          </p:cNvPr>
          <p:cNvSpPr txBox="1"/>
          <p:nvPr/>
        </p:nvSpPr>
        <p:spPr>
          <a:xfrm>
            <a:off x="254643" y="196534"/>
            <a:ext cx="9782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 Table 7  Steatosis, lobular inflammation, ballooning degeneration and NAFLD activity score (Table 2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7D616E2-83AE-4177-A28D-5BFECDC945CD}"/>
              </a:ext>
            </a:extLst>
          </p:cNvPr>
          <p:cNvSpPr txBox="1"/>
          <p:nvPr/>
        </p:nvSpPr>
        <p:spPr>
          <a:xfrm>
            <a:off x="8124839" y="2390774"/>
            <a:ext cx="32099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ndividual scores for steatosis (0–3), inflammation (0–3) and ballooning (0–2) were provided and were added up to determine the NAFLD activity score as a semi-quantitative measure of disease severity. Steatosis, inflammation and hepatocyte ballooning were scored according to the previous report [33]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364CB02-DD4A-423C-8024-FC8E44C59A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250" y="747659"/>
            <a:ext cx="6996308" cy="53626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8990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47</Words>
  <Application>Microsoft Office PowerPoint</Application>
  <PresentationFormat>ワイド画面</PresentationFormat>
  <Paragraphs>8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suharu.matsumoto</dc:creator>
  <cp:lastModifiedBy>mitsuharu.matsumoto</cp:lastModifiedBy>
  <cp:revision>8</cp:revision>
  <dcterms:created xsi:type="dcterms:W3CDTF">2020-01-16T00:35:14Z</dcterms:created>
  <dcterms:modified xsi:type="dcterms:W3CDTF">2020-01-16T03:04:33Z</dcterms:modified>
</cp:coreProperties>
</file>